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08" d="100"/>
          <a:sy n="108" d="100"/>
        </p:scale>
        <p:origin x="630" y="102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Roxanne Assies" userId="7664e6967585e71c" providerId="LiveId" clId="{58FD4E7D-F9E6-40E3-BDE5-F78C2A7B2930}"/>
    <pc:docChg chg="modSld">
      <pc:chgData name="Roxanne Assies" userId="7664e6967585e71c" providerId="LiveId" clId="{58FD4E7D-F9E6-40E3-BDE5-F78C2A7B2930}" dt="2022-05-05T12:41:07.796" v="16" actId="1076"/>
      <pc:docMkLst>
        <pc:docMk/>
      </pc:docMkLst>
      <pc:sldChg chg="modSp mod">
        <pc:chgData name="Roxanne Assies" userId="7664e6967585e71c" providerId="LiveId" clId="{58FD4E7D-F9E6-40E3-BDE5-F78C2A7B2930}" dt="2022-05-05T12:41:07.796" v="16" actId="1076"/>
        <pc:sldMkLst>
          <pc:docMk/>
          <pc:sldMk cId="566403560" sldId="264"/>
        </pc:sldMkLst>
        <pc:spChg chg="mod">
          <ac:chgData name="Roxanne Assies" userId="7664e6967585e71c" providerId="LiveId" clId="{58FD4E7D-F9E6-40E3-BDE5-F78C2A7B2930}" dt="2022-05-05T12:41:07.796" v="16" actId="1076"/>
          <ac:spMkLst>
            <pc:docMk/>
            <pc:sldMk cId="566403560" sldId="264"/>
            <ac:spMk id="3" creationId="{2F876AF3-4C62-4573-873F-79080D7E4A39}"/>
          </ac:spMkLst>
        </pc:spChg>
        <pc:picChg chg="mod">
          <ac:chgData name="Roxanne Assies" userId="7664e6967585e71c" providerId="LiveId" clId="{58FD4E7D-F9E6-40E3-BDE5-F78C2A7B2930}" dt="2022-05-05T12:39:15.976" v="2" actId="1076"/>
          <ac:picMkLst>
            <pc:docMk/>
            <pc:sldMk cId="566403560" sldId="264"/>
            <ac:picMk id="5" creationId="{6E1B32F5-F52C-4912-9545-64E580E0EF66}"/>
          </ac:picMkLst>
        </pc:picChg>
        <pc:picChg chg="mod">
          <ac:chgData name="Roxanne Assies" userId="7664e6967585e71c" providerId="LiveId" clId="{58FD4E7D-F9E6-40E3-BDE5-F78C2A7B2930}" dt="2022-05-05T12:40:41.610" v="12" actId="1076"/>
          <ac:picMkLst>
            <pc:docMk/>
            <pc:sldMk cId="566403560" sldId="264"/>
            <ac:picMk id="7" creationId="{AFA46A88-F3E2-4BD5-A5E5-B9AE369BC94C}"/>
          </ac:picMkLst>
        </pc:picChg>
        <pc:picChg chg="mod modCrop">
          <ac:chgData name="Roxanne Assies" userId="7664e6967585e71c" providerId="LiveId" clId="{58FD4E7D-F9E6-40E3-BDE5-F78C2A7B2930}" dt="2022-05-05T12:40:25.995" v="10" actId="1076"/>
          <ac:picMkLst>
            <pc:docMk/>
            <pc:sldMk cId="566403560" sldId="264"/>
            <ac:picMk id="8" creationId="{9D9314D2-4224-4476-BC26-4991D98AED9E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2FB15F-8F68-2167-01D5-95F9126E169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77EA986-1AD1-A5FE-8A8C-A0DD1DA5EC8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4EC3AF5-EECE-5093-2589-37FC43762A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F24BAE-17B0-43EC-A3FD-B2597BD8E9CD}" type="datetimeFigureOut">
              <a:rPr lang="en-US" smtClean="0"/>
              <a:t>5/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3665C7-D1EC-CB15-08B0-FC99A72272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1C8A596-CF1B-7146-4E3A-422AC57A73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B43FE-C322-4DEA-ACF0-9F505695C6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41577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ECAC7B-C91D-75E4-A955-E5653539C7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872AD0D-2253-CC57-7785-49A998D2434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07DBDC-18A8-78AC-B63F-48E637E6A3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F24BAE-17B0-43EC-A3FD-B2597BD8E9CD}" type="datetimeFigureOut">
              <a:rPr lang="en-US" smtClean="0"/>
              <a:t>5/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6FCAD8-3300-3972-4CEB-1C033593C9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6819C64-B60F-C24C-A666-6D1315A7D8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B43FE-C322-4DEA-ACF0-9F505695C6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49076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36B6F3E-4288-A882-974A-925B815E564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BEE72FD-5A77-0260-B4BA-D1FFBD18332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F7960C4-BC08-924A-791B-6F0128E647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F24BAE-17B0-43EC-A3FD-B2597BD8E9CD}" type="datetimeFigureOut">
              <a:rPr lang="en-US" smtClean="0"/>
              <a:t>5/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E5E0213-12CB-CE55-B31E-8D071AB127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7AE7CCF-B217-CBB3-530B-6B8C7AF676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B43FE-C322-4DEA-ACF0-9F505695C6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13261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016DB4-BF60-02C8-54AE-8DAF8DF7EB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A0D12C0-02DC-52AF-D806-E62E7AAF0DB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354C9E7-98A4-A1D9-D502-A1FEF36255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F24BAE-17B0-43EC-A3FD-B2597BD8E9CD}" type="datetimeFigureOut">
              <a:rPr lang="en-US" smtClean="0"/>
              <a:t>5/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780EEA5-9BE2-B6DE-7052-CEA5DD1D4C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E15A3CD-0C12-83A1-2DBF-634884DDB1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B43FE-C322-4DEA-ACF0-9F505695C6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68020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B9614E-13F6-FA3D-ED3E-5E2C27ADFE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47510EA-D277-E219-61B0-BE7149F86C1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6131E99-6503-F45E-3249-11BC5945E2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F24BAE-17B0-43EC-A3FD-B2597BD8E9CD}" type="datetimeFigureOut">
              <a:rPr lang="en-US" smtClean="0"/>
              <a:t>5/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D3A15F5-3B11-33BC-13EF-96D7BD2E69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EF41785-3064-8B06-65D8-A90D452F0F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B43FE-C322-4DEA-ACF0-9F505695C6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45184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72ADC9-DEDD-1B5C-2439-D40751E42C0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2795522-9FD1-97F7-E6CB-9F94677836B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A092E0E-C1A4-C7B8-B05B-9DE809CEC79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172A3B7-98E1-622B-49BE-C7C36CA836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F24BAE-17B0-43EC-A3FD-B2597BD8E9CD}" type="datetimeFigureOut">
              <a:rPr lang="en-US" smtClean="0"/>
              <a:t>5/5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0336867-BF1C-8D23-FF7B-392423FA45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F933759-C018-5B7A-BE62-B068F13B00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B43FE-C322-4DEA-ACF0-9F505695C6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6696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D85DB5-4C5F-F64F-6648-D6B0BAB62E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B9E12F7-3543-289B-92E3-5EBDBC31AF6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70952EB-9554-F9B9-4516-3A73F8374A6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6F21736-9EE4-F4A4-8809-EEE873F0DC8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3DFC0C1-087E-4EEF-8498-C4837ABE31B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170E0FC-8138-F287-CD11-132828873F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F24BAE-17B0-43EC-A3FD-B2597BD8E9CD}" type="datetimeFigureOut">
              <a:rPr lang="en-US" smtClean="0"/>
              <a:t>5/5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D69F1E5-0556-D028-B197-17327C8ACC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BAB1825-236D-E52C-840F-F67011A932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B43FE-C322-4DEA-ACF0-9F505695C6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7874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3558BC-AE80-F5C1-C42D-CEE13EF6B7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5AC013C-F556-B5AA-8956-52889BF395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F24BAE-17B0-43EC-A3FD-B2597BD8E9CD}" type="datetimeFigureOut">
              <a:rPr lang="en-US" smtClean="0"/>
              <a:t>5/5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932E3A9-2BEC-3CAC-0BBD-CDC9C4402B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9016AC0-4C63-3FDF-AF45-04059224A0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B43FE-C322-4DEA-ACF0-9F505695C6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98664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C49A666-AEA0-5A09-09F5-6BD825542A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F24BAE-17B0-43EC-A3FD-B2597BD8E9CD}" type="datetimeFigureOut">
              <a:rPr lang="en-US" smtClean="0"/>
              <a:t>5/5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0F91E4A-813A-FCA3-E7EE-A239D2143A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F7D20BD-D8B6-CD1C-48B7-E5F5F5F26E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B43FE-C322-4DEA-ACF0-9F505695C6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22682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8091CAE-4A8E-FC1E-99FE-85A53FA610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24845F0-E925-36A5-E03F-A3225EE7B9B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F072E00-0D1E-BF7D-60FC-4F91CD75B06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228C0D9-57D8-C7D6-660C-CF15D13AD6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F24BAE-17B0-43EC-A3FD-B2597BD8E9CD}" type="datetimeFigureOut">
              <a:rPr lang="en-US" smtClean="0"/>
              <a:t>5/5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4B79A39-80EB-90EF-9A9B-411570BA8E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5C6AB48-5F07-8DC7-0745-7A877FD3FD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B43FE-C322-4DEA-ACF0-9F505695C6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97203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E5F9B9-A014-85B9-B774-87C6A3953E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F3EDE67-8AF2-3C06-F8FA-EE82626F310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8754616-E3D3-BD30-0EC2-0EC813BFF1D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2EC77BD-7745-2EF7-D6D4-BCBBDDF816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F24BAE-17B0-43EC-A3FD-B2597BD8E9CD}" type="datetimeFigureOut">
              <a:rPr lang="en-US" smtClean="0"/>
              <a:t>5/5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6E877FA-FE02-283A-D52E-9BA76A3FB4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F04CA79-37B6-8F49-9890-81CE52F405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B43FE-C322-4DEA-ACF0-9F505695C6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55611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699F2D4-4A01-7F80-7ECF-F77425541D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4117732-52E2-1A71-CFE1-66264837E0D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E97BA6B-3D9B-490D-7BD9-C9CE12FEDD6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F24BAE-17B0-43EC-A3FD-B2597BD8E9CD}" type="datetimeFigureOut">
              <a:rPr lang="en-US" smtClean="0"/>
              <a:t>5/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AF0F2A0-2097-DDC6-6BC3-FD550528867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B7473B2-776F-6DA4-0D1D-7E8842587C4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BB43FE-C322-4DEA-ACF0-9F505695C6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39375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Diagram&#10;&#10;Description automatically generated">
            <a:extLst>
              <a:ext uri="{FF2B5EF4-FFF2-40B4-BE49-F238E27FC236}">
                <a16:creationId xmlns:a16="http://schemas.microsoft.com/office/drawing/2014/main" id="{6E1B32F5-F52C-4912-9545-64E580E0EF6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6000" b="47174"/>
          <a:stretch/>
        </p:blipFill>
        <p:spPr>
          <a:xfrm>
            <a:off x="204188" y="341512"/>
            <a:ext cx="5568651" cy="4614025"/>
          </a:xfrm>
          <a:prstGeom prst="rect">
            <a:avLst/>
          </a:prstGeom>
        </p:spPr>
      </p:pic>
      <p:pic>
        <p:nvPicPr>
          <p:cNvPr id="8" name="Picture 7" descr="Diagram&#10;&#10;Description automatically generated">
            <a:extLst>
              <a:ext uri="{FF2B5EF4-FFF2-40B4-BE49-F238E27FC236}">
                <a16:creationId xmlns:a16="http://schemas.microsoft.com/office/drawing/2014/main" id="{9D9314D2-4224-4476-BC26-4991D98AED9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953" b="90741"/>
          <a:stretch/>
        </p:blipFill>
        <p:spPr>
          <a:xfrm>
            <a:off x="5705629" y="283529"/>
            <a:ext cx="5568651" cy="345172"/>
          </a:xfrm>
          <a:prstGeom prst="rect">
            <a:avLst/>
          </a:prstGeom>
        </p:spPr>
      </p:pic>
      <p:pic>
        <p:nvPicPr>
          <p:cNvPr id="7" name="Picture 6" descr="Diagram&#10;&#10;Description automatically generated">
            <a:extLst>
              <a:ext uri="{FF2B5EF4-FFF2-40B4-BE49-F238E27FC236}">
                <a16:creationId xmlns:a16="http://schemas.microsoft.com/office/drawing/2014/main" id="{AFA46A88-F3E2-4BD5-A5E5-B9AE369BC94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3841" b="15053"/>
          <a:stretch/>
        </p:blipFill>
        <p:spPr>
          <a:xfrm>
            <a:off x="5705628" y="686684"/>
            <a:ext cx="5568651" cy="3897299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2F876AF3-4C62-4573-873F-79080D7E4A39}"/>
              </a:ext>
            </a:extLst>
          </p:cNvPr>
          <p:cNvSpPr txBox="1"/>
          <p:nvPr/>
        </p:nvSpPr>
        <p:spPr>
          <a:xfrm>
            <a:off x="6031487" y="4641966"/>
            <a:ext cx="4984143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: Forest plot including the overall pooled mortality as well as subgroup analysis per region</a:t>
            </a:r>
          </a:p>
        </p:txBody>
      </p:sp>
    </p:spTree>
    <p:extLst>
      <p:ext uri="{BB962C8B-B14F-4D97-AF65-F5344CB8AC3E}">
        <p14:creationId xmlns:p14="http://schemas.microsoft.com/office/powerpoint/2010/main" val="5664035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xanne Assies</dc:creator>
  <cp:lastModifiedBy>Roxanne Assies</cp:lastModifiedBy>
  <cp:revision>1</cp:revision>
  <dcterms:created xsi:type="dcterms:W3CDTF">2022-05-05T12:21:06Z</dcterms:created>
  <dcterms:modified xsi:type="dcterms:W3CDTF">2022-05-05T12:41:10Z</dcterms:modified>
</cp:coreProperties>
</file>